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0520025" cy="86407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89AD3-ED85-4CB3-BDE2-4B329BEBAA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411200" y="2300400"/>
            <a:ext cx="176976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411200" y="5163480"/>
            <a:ext cx="176976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318CB8-8B90-47FD-8F3C-F8878E622B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411200" y="230040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0479960" y="230040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411200" y="516348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0479960" y="516348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F9B99-49EA-445B-8759-36CBE7D312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411200" y="2300400"/>
            <a:ext cx="569844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7395120" y="2300400"/>
            <a:ext cx="569844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3378680" y="2300400"/>
            <a:ext cx="569844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411200" y="5163480"/>
            <a:ext cx="569844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7395120" y="5163480"/>
            <a:ext cx="569844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3378680" y="5163480"/>
            <a:ext cx="569844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1BDD2-2774-4D47-A1FA-6025B389C4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411200" y="2300400"/>
            <a:ext cx="17697600" cy="548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261"/>
              </a:spcBef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9A03D-03E5-4189-B5E1-DBA1BCEE2F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411200" y="2300400"/>
            <a:ext cx="17697600" cy="54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CC31C-8119-4E31-A57B-95A665D8F4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411200" y="2300400"/>
            <a:ext cx="8636400" cy="54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0479960" y="2300400"/>
            <a:ext cx="8636400" cy="54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7CD2DC-558B-4BAD-8D03-F2957C5738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62D02-22BC-47A0-8D75-EFC44BFFD9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411200" y="460080"/>
            <a:ext cx="17697600" cy="774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261"/>
              </a:spcBef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769A7-AF65-4E70-B8BC-D0AA1F3E80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411200" y="230040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0479960" y="2300400"/>
            <a:ext cx="8636400" cy="54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411200" y="516348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EFB472-915C-4064-BB40-9B91005B0E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411200" y="2300400"/>
            <a:ext cx="8636400" cy="54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0479960" y="230040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0479960" y="516348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47F10-9872-46AA-850F-013207E9D7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411200" y="230040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0479960" y="2300400"/>
            <a:ext cx="86364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411200" y="5163480"/>
            <a:ext cx="17697600" cy="2614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261"/>
              </a:spcBef>
              <a:buNone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25AAD-652F-48F5-AB24-84AE3A9866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411200" y="460080"/>
            <a:ext cx="17697600" cy="167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r>
              <a:rPr b="0" lang="en-US" sz="55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5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411200" y="2300400"/>
            <a:ext cx="17697600" cy="54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87280" indent="-287280">
              <a:lnSpc>
                <a:spcPct val="90000"/>
              </a:lnSpc>
              <a:spcBef>
                <a:spcPts val="1261"/>
              </a:spcBef>
              <a:buClr>
                <a:srgbClr val="000000"/>
              </a:buClr>
              <a:buFont typeface="Arial"/>
              <a:buChar char="•"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1" marL="863640" indent="-287280">
              <a:lnSpc>
                <a:spcPct val="90000"/>
              </a:lnSpc>
              <a:spcBef>
                <a:spcPts val="1261"/>
              </a:spcBef>
              <a:buClr>
                <a:srgbClr val="000000"/>
              </a:buClr>
              <a:buFont typeface="Arial"/>
              <a:buChar char="•"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2" marL="1440000" indent="-287640">
              <a:lnSpc>
                <a:spcPct val="90000"/>
              </a:lnSpc>
              <a:spcBef>
                <a:spcPts val="1261"/>
              </a:spcBef>
              <a:buClr>
                <a:srgbClr val="000000"/>
              </a:buClr>
              <a:buFont typeface="Arial"/>
              <a:buChar char="•"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3" marL="2016000" indent="-287280">
              <a:lnSpc>
                <a:spcPct val="90000"/>
              </a:lnSpc>
              <a:spcBef>
                <a:spcPts val="1261"/>
              </a:spcBef>
              <a:buClr>
                <a:srgbClr val="000000"/>
              </a:buClr>
              <a:buFont typeface="Arial"/>
              <a:buChar char="•"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4" marL="2590920" indent="-287280">
              <a:lnSpc>
                <a:spcPct val="90000"/>
              </a:lnSpc>
              <a:spcBef>
                <a:spcPts val="1261"/>
              </a:spcBef>
              <a:buClr>
                <a:srgbClr val="000000"/>
              </a:buClr>
              <a:buFont typeface="Arial"/>
              <a:buChar char="•"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5" marL="2590920" indent="-287280">
              <a:lnSpc>
                <a:spcPct val="90000"/>
              </a:lnSpc>
              <a:spcBef>
                <a:spcPts val="1261"/>
              </a:spcBef>
              <a:buClr>
                <a:srgbClr val="000000"/>
              </a:buClr>
              <a:buFont typeface="Arial"/>
              <a:buChar char="•"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  <a:p>
            <a:pPr lvl="6" marL="2590920" indent="-287280">
              <a:lnSpc>
                <a:spcPct val="90000"/>
              </a:lnSpc>
              <a:spcBef>
                <a:spcPts val="1261"/>
              </a:spcBef>
              <a:buClr>
                <a:srgbClr val="000000"/>
              </a:buClr>
              <a:buFont typeface="Arial"/>
              <a:buChar char="•"/>
              <a:tabLst>
                <a:tab algn="l" pos="1150920"/>
                <a:tab algn="l" pos="2301840"/>
                <a:tab algn="l" pos="3452760"/>
                <a:tab algn="l" pos="4603680"/>
                <a:tab algn="l" pos="5754600"/>
                <a:tab algn="l" pos="6905520"/>
                <a:tab algn="l" pos="8056440"/>
                <a:tab algn="l" pos="9207360"/>
                <a:tab algn="l" pos="10358280"/>
              </a:tabLst>
            </a:pPr>
            <a:r>
              <a:rPr b="0" lang="en-US" sz="3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411200" y="8008560"/>
            <a:ext cx="461664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l-GR" sz="15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5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6797520" y="8008560"/>
            <a:ext cx="692496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4492160" y="8008560"/>
            <a:ext cx="461664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l-GR" sz="15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DE05F62-112F-4B33-BBFA-AB33A3BB9826}" type="slidenum">
              <a:rPr b="0" lang="el-GR" sz="15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Ομάδα 2"/>
          <p:cNvGrpSpPr/>
          <p:nvPr/>
        </p:nvGrpSpPr>
        <p:grpSpPr>
          <a:xfrm>
            <a:off x="276120" y="54000"/>
            <a:ext cx="19963080" cy="8116920"/>
            <a:chOff x="276120" y="54000"/>
            <a:chExt cx="19963080" cy="8116920"/>
          </a:xfrm>
        </p:grpSpPr>
        <p:grpSp>
          <p:nvGrpSpPr>
            <p:cNvPr id="42" name="Ομάδα 90"/>
            <p:cNvGrpSpPr/>
            <p:nvPr/>
          </p:nvGrpSpPr>
          <p:grpSpPr>
            <a:xfrm>
              <a:off x="276120" y="597240"/>
              <a:ext cx="19963080" cy="7573680"/>
              <a:chOff x="276120" y="597240"/>
              <a:chExt cx="19963080" cy="7573680"/>
            </a:xfrm>
          </p:grpSpPr>
          <p:grpSp>
            <p:nvGrpSpPr>
              <p:cNvPr id="43" name="Ομάδα 12"/>
              <p:cNvGrpSpPr/>
              <p:nvPr/>
            </p:nvGrpSpPr>
            <p:grpSpPr>
              <a:xfrm>
                <a:off x="6481800" y="3117960"/>
                <a:ext cx="6518880" cy="5052960"/>
                <a:chOff x="6481800" y="3117960"/>
                <a:chExt cx="6518880" cy="5052960"/>
              </a:xfrm>
            </p:grpSpPr>
            <p:sp>
              <p:nvSpPr>
                <p:cNvPr id="44" name="Straight Connector 207"/>
                <p:cNvSpPr/>
                <p:nvPr/>
              </p:nvSpPr>
              <p:spPr>
                <a:xfrm flipH="1" flipV="1">
                  <a:off x="10119960" y="3117960"/>
                  <a:ext cx="1199880" cy="2130480"/>
                </a:xfrm>
                <a:prstGeom prst="line">
                  <a:avLst/>
                </a:prstGeom>
                <a:ln w="12600">
                  <a:solidFill>
                    <a:srgbClr val="ed7d31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" name="Straight Connector 414"/>
                <p:cNvSpPr/>
                <p:nvPr/>
              </p:nvSpPr>
              <p:spPr>
                <a:xfrm flipH="1">
                  <a:off x="9045000" y="3117960"/>
                  <a:ext cx="695160" cy="1608120"/>
                </a:xfrm>
                <a:prstGeom prst="line">
                  <a:avLst/>
                </a:prstGeom>
                <a:ln w="12600">
                  <a:solidFill>
                    <a:srgbClr val="ed7d31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46" name="Picture 22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6481800" y="3373560"/>
                  <a:ext cx="6518880" cy="47973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47" name="Ομάδα 1"/>
              <p:cNvGrpSpPr/>
              <p:nvPr/>
            </p:nvGrpSpPr>
            <p:grpSpPr>
              <a:xfrm>
                <a:off x="276120" y="597240"/>
                <a:ext cx="9467280" cy="2511360"/>
                <a:chOff x="276120" y="597240"/>
                <a:chExt cx="9467280" cy="2511360"/>
              </a:xfrm>
            </p:grpSpPr>
            <p:grpSp>
              <p:nvGrpSpPr>
                <p:cNvPr id="48" name="Group 267"/>
                <p:cNvGrpSpPr/>
                <p:nvPr/>
              </p:nvGrpSpPr>
              <p:grpSpPr>
                <a:xfrm>
                  <a:off x="276120" y="863640"/>
                  <a:ext cx="9467280" cy="2244960"/>
                  <a:chOff x="276120" y="863640"/>
                  <a:chExt cx="9467280" cy="2244960"/>
                </a:xfrm>
              </p:grpSpPr>
              <p:sp>
                <p:nvSpPr>
                  <p:cNvPr id="49" name="Rectangle 268"/>
                  <p:cNvSpPr/>
                  <p:nvPr/>
                </p:nvSpPr>
                <p:spPr>
                  <a:xfrm>
                    <a:off x="280800" y="2157480"/>
                    <a:ext cx="9461160" cy="264960"/>
                  </a:xfrm>
                  <a:prstGeom prst="rect">
                    <a:avLst/>
                  </a:prstGeom>
                  <a:solidFill>
                    <a:srgbClr val="fcd5b5"/>
                  </a:solidFill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just">
                      <a:lnSpc>
                        <a:spcPct val="100000"/>
                      </a:lnSpc>
                      <a:tabLst>
                        <a:tab algn="l" pos="0"/>
                        <a:tab algn="l" pos="2754360"/>
                        <a:tab algn="l" pos="5508720"/>
                        <a:tab algn="l" pos="8263080"/>
                      </a:tabLst>
                    </a:pPr>
                    <a:r>
                      <a:rPr b="1" lang="en-GB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CDR2:TGGGCATCC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" name="Rectangle 269"/>
                  <p:cNvSpPr/>
                  <p:nvPr/>
                </p:nvSpPr>
                <p:spPr>
                  <a:xfrm>
                    <a:off x="280800" y="2422800"/>
                    <a:ext cx="9461160" cy="442800"/>
                  </a:xfrm>
                  <a:prstGeom prst="rect">
                    <a:avLst/>
                  </a:prstGeom>
                  <a:gradFill rotWithShape="0">
                    <a:gsLst>
                      <a:gs pos="0">
                        <a:srgbClr val="d0c2e2"/>
                      </a:gs>
                      <a:gs pos="100000">
                        <a:srgbClr val="f0ecf5"/>
                      </a:gs>
                    </a:gsLst>
                    <a:lin ang="2700000"/>
                  </a:gradFill>
                  <a:ln w="25560">
                    <a:solidFill>
                      <a:srgbClr val="604a7b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just">
                      <a:lnSpc>
                        <a:spcPct val="100000"/>
                      </a:lnSpc>
                      <a:tabLst>
                        <a:tab algn="l" pos="0"/>
                        <a:tab algn="l" pos="2754360"/>
                        <a:tab algn="l" pos="5508720"/>
                        <a:tab algn="l" pos="8263080"/>
                      </a:tabLst>
                    </a:pPr>
                    <a:r>
                      <a:rPr b="1" lang="en-GB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FR3:ACTAGGGAATCTGGTGTCCCTGATCGCTTCACAGGCAGTGGATCTGGGACAGATTTTACTCTTACCATCAGCAGTGTACAAGCTGAAGACCTGGCAGTTTATAC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" name="Rectangle 270"/>
                  <p:cNvSpPr/>
                  <p:nvPr/>
                </p:nvSpPr>
                <p:spPr>
                  <a:xfrm>
                    <a:off x="276120" y="2851560"/>
                    <a:ext cx="9467280" cy="257040"/>
                  </a:xfrm>
                  <a:prstGeom prst="rect">
                    <a:avLst/>
                  </a:prstGeom>
                  <a:solidFill>
                    <a:srgbClr val="fcd5b5"/>
                  </a:solidFill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just">
                      <a:lnSpc>
                        <a:spcPct val="100000"/>
                      </a:lnSpc>
                      <a:tabLst>
                        <a:tab algn="l" pos="0"/>
                        <a:tab algn="l" pos="2754360"/>
                        <a:tab algn="l" pos="5508720"/>
                        <a:tab algn="l" pos="8263080"/>
                      </a:tabLst>
                    </a:pPr>
                    <a:r>
                      <a:rPr b="1" lang="en-GB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CDR3:TGTCATCAATACCTCTCCTCGCTCACGTTC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Rectangle 271"/>
                  <p:cNvSpPr/>
                  <p:nvPr/>
                </p:nvSpPr>
                <p:spPr>
                  <a:xfrm>
                    <a:off x="280800" y="863640"/>
                    <a:ext cx="9461160" cy="563400"/>
                  </a:xfrm>
                  <a:prstGeom prst="rect">
                    <a:avLst/>
                  </a:prstGeom>
                  <a:gradFill rotWithShape="0">
                    <a:gsLst>
                      <a:gs pos="0">
                        <a:srgbClr val="d0c2e2"/>
                      </a:gs>
                      <a:gs pos="100000">
                        <a:srgbClr val="f0ecf5"/>
                      </a:gs>
                    </a:gsLst>
                    <a:lin ang="5400000"/>
                  </a:gradFill>
                  <a:ln w="25560">
                    <a:solidFill>
                      <a:srgbClr val="604a7b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just">
                      <a:lnSpc>
                        <a:spcPct val="100000"/>
                      </a:lnSpc>
                      <a:tabLst>
                        <a:tab algn="l" pos="0"/>
                        <a:tab algn="l" pos="2754360"/>
                        <a:tab algn="l" pos="5508720"/>
                        <a:tab algn="l" pos="8263080"/>
                      </a:tabLst>
                    </a:pPr>
                    <a:r>
                      <a:rPr b="1" lang="en-GB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FR1:AACATTATGATGACACAGTCGCCATCATCTCTGGCTGTGTCTGCAGGAGAAAAGGTCACTATGAGCTGTAAGTCCAGTT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Rectangle 272"/>
                  <p:cNvSpPr/>
                  <p:nvPr/>
                </p:nvSpPr>
                <p:spPr>
                  <a:xfrm>
                    <a:off x="280800" y="1387440"/>
                    <a:ext cx="9461160" cy="293760"/>
                  </a:xfrm>
                  <a:prstGeom prst="rect">
                    <a:avLst/>
                  </a:prstGeom>
                  <a:solidFill>
                    <a:srgbClr val="fcd5b5"/>
                  </a:solidFill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just">
                      <a:lnSpc>
                        <a:spcPct val="100000"/>
                      </a:lnSpc>
                      <a:tabLst>
                        <a:tab algn="l" pos="0"/>
                        <a:tab algn="l" pos="2754360"/>
                        <a:tab algn="l" pos="5508720"/>
                        <a:tab algn="l" pos="8263080"/>
                      </a:tabLst>
                    </a:pPr>
                    <a:r>
                      <a:rPr b="1" lang="en-GB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CDR1:CAAAGTGTTTTATACAGTTCAAATCAGAAGAACTAC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" name="Rectangle 273"/>
                  <p:cNvSpPr/>
                  <p:nvPr/>
                </p:nvSpPr>
                <p:spPr>
                  <a:xfrm>
                    <a:off x="280800" y="1681200"/>
                    <a:ext cx="9461160" cy="476280"/>
                  </a:xfrm>
                  <a:prstGeom prst="rect">
                    <a:avLst/>
                  </a:prstGeom>
                  <a:gradFill rotWithShape="0">
                    <a:gsLst>
                      <a:gs pos="0">
                        <a:srgbClr val="d0c2e2"/>
                      </a:gs>
                      <a:gs pos="100000">
                        <a:srgbClr val="f0ecf5"/>
                      </a:gs>
                    </a:gsLst>
                    <a:lin ang="2700000"/>
                  </a:gradFill>
                  <a:ln w="25560">
                    <a:solidFill>
                      <a:srgbClr val="604a7b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just">
                      <a:lnSpc>
                        <a:spcPct val="100000"/>
                      </a:lnSpc>
                      <a:tabLst>
                        <a:tab algn="l" pos="0"/>
                        <a:tab algn="l" pos="2754360"/>
                        <a:tab algn="l" pos="5508720"/>
                        <a:tab algn="l" pos="8263080"/>
                      </a:tabLst>
                    </a:pP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 algn="just">
                      <a:lnSpc>
                        <a:spcPct val="100000"/>
                      </a:lnSpc>
                      <a:tabLst>
                        <a:tab algn="l" pos="0"/>
                        <a:tab algn="l" pos="2754360"/>
                        <a:tab algn="l" pos="5508720"/>
                        <a:tab algn="l" pos="8263080"/>
                      </a:tabLst>
                    </a:pPr>
                    <a:r>
                      <a:rPr b="1" lang="en-GB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FR2:TTGGCCTGGTACCAGCAGAAACCAGGGCAGTCTCCTAAACTGCTGATCTAC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 algn="just">
                      <a:lnSpc>
                        <a:spcPct val="100000"/>
                      </a:lnSpc>
                      <a:tabLst>
                        <a:tab algn="l" pos="0"/>
                        <a:tab algn="l" pos="2754360"/>
                        <a:tab algn="l" pos="5508720"/>
                        <a:tab algn="l" pos="8263080"/>
                      </a:tabLst>
                    </a:pP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5" name="Rectangle 394"/>
                <p:cNvSpPr/>
                <p:nvPr/>
              </p:nvSpPr>
              <p:spPr>
                <a:xfrm>
                  <a:off x="276120" y="597240"/>
                  <a:ext cx="9465120" cy="264960"/>
                </a:xfrm>
                <a:prstGeom prst="rect">
                  <a:avLst/>
                </a:prstGeom>
                <a:solidFill>
                  <a:srgbClr val="b9cde5"/>
                </a:solidFill>
                <a:ln w="25560">
                  <a:solidFill>
                    <a:srgbClr val="604a7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2754360"/>
                      <a:tab algn="l" pos="5508720"/>
                      <a:tab algn="l" pos="8263080"/>
                    </a:tabLst>
                  </a:pPr>
                  <a:r>
                    <a:rPr b="1" lang="en-GB" sz="1200" spc="-1" strike="noStrike">
                      <a:solidFill>
                        <a:srgbClr val="000000"/>
                      </a:solidFill>
                      <a:latin typeface="Calibri"/>
                    </a:rPr>
                    <a:t>DNA sequence of CDRs and FRs of Light chain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6" name="Ομάδα 73"/>
              <p:cNvGrpSpPr/>
              <p:nvPr/>
            </p:nvGrpSpPr>
            <p:grpSpPr>
              <a:xfrm>
                <a:off x="10114200" y="785880"/>
                <a:ext cx="10125000" cy="2294640"/>
                <a:chOff x="10114200" y="785880"/>
                <a:chExt cx="10125000" cy="2294640"/>
              </a:xfrm>
            </p:grpSpPr>
            <p:grpSp>
              <p:nvGrpSpPr>
                <p:cNvPr id="57" name="Group 274"/>
                <p:cNvGrpSpPr/>
                <p:nvPr/>
              </p:nvGrpSpPr>
              <p:grpSpPr>
                <a:xfrm>
                  <a:off x="10139040" y="1029600"/>
                  <a:ext cx="10075680" cy="1808640"/>
                  <a:chOff x="10139040" y="1029600"/>
                  <a:chExt cx="10075680" cy="1808640"/>
                </a:xfrm>
              </p:grpSpPr>
              <p:grpSp>
                <p:nvGrpSpPr>
                  <p:cNvPr id="58" name="Rectangle 275"/>
                  <p:cNvGrpSpPr/>
                  <p:nvPr/>
                </p:nvGrpSpPr>
                <p:grpSpPr>
                  <a:xfrm>
                    <a:off x="10144800" y="1029600"/>
                    <a:ext cx="10069920" cy="460800"/>
                    <a:chOff x="10144800" y="1029600"/>
                    <a:chExt cx="10069920" cy="460800"/>
                  </a:xfrm>
                </p:grpSpPr>
                <p:pic>
                  <p:nvPicPr>
                    <p:cNvPr id="59" name="Rectangle 275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0144800" y="1029600"/>
                      <a:ext cx="10069920" cy="460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60" name=""/>
                    <p:cNvSpPr/>
                    <p:nvPr/>
                  </p:nvSpPr>
                  <p:spPr>
                    <a:xfrm>
                      <a:off x="10172160" y="1058400"/>
                      <a:ext cx="10012320" cy="4042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268200"/>
                          <a:tab algn="l" pos="536400"/>
                          <a:tab algn="l" pos="804960"/>
                          <a:tab algn="l" pos="1073160"/>
                          <a:tab algn="l" pos="1341360"/>
                          <a:tab algn="l" pos="1609560"/>
                          <a:tab algn="l" pos="1878120"/>
                          <a:tab algn="l" pos="2146320"/>
                          <a:tab algn="l" pos="2414520"/>
                          <a:tab algn="l" pos="2682720"/>
                          <a:tab algn="l" pos="2951280"/>
                          <a:tab algn="l" pos="3219480"/>
                          <a:tab algn="l" pos="3487680"/>
                          <a:tab algn="l" pos="3755880"/>
                          <a:tab algn="l" pos="4024440"/>
                          <a:tab algn="l" pos="4292640"/>
                          <a:tab algn="l" pos="4560840"/>
                          <a:tab algn="l" pos="4829040"/>
                          <a:tab algn="l" pos="5097600"/>
                          <a:tab algn="l" pos="53658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1:GAAGTGATGCTGGTGGAGTCTGGGGGAGGCTTAGTGAGGCCTGGAGGGACCCTGAAACTCTCCTGTGCAGCCT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61" name="Rectangle 276"/>
                  <p:cNvGrpSpPr/>
                  <p:nvPr/>
                </p:nvGrpSpPr>
                <p:grpSpPr>
                  <a:xfrm>
                    <a:off x="10144800" y="1438560"/>
                    <a:ext cx="10063800" cy="293760"/>
                    <a:chOff x="10144800" y="1438560"/>
                    <a:chExt cx="10063800" cy="293760"/>
                  </a:xfrm>
                </p:grpSpPr>
                <p:pic>
                  <p:nvPicPr>
                    <p:cNvPr id="62" name="Rectangle 276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10144800" y="1438560"/>
                      <a:ext cx="10063800" cy="293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63" name=""/>
                    <p:cNvSpPr/>
                    <p:nvPr/>
                  </p:nvSpPr>
                  <p:spPr>
                    <a:xfrm>
                      <a:off x="10173960" y="1462680"/>
                      <a:ext cx="10006200" cy="24156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268200"/>
                          <a:tab algn="l" pos="536400"/>
                          <a:tab algn="l" pos="804960"/>
                          <a:tab algn="l" pos="1073160"/>
                          <a:tab algn="l" pos="1341360"/>
                          <a:tab algn="l" pos="1609560"/>
                          <a:tab algn="l" pos="1878120"/>
                          <a:tab algn="l" pos="2146320"/>
                          <a:tab algn="l" pos="2414520"/>
                          <a:tab algn="l" pos="2682720"/>
                          <a:tab algn="l" pos="2951280"/>
                          <a:tab algn="l" pos="3219480"/>
                          <a:tab algn="l" pos="3487680"/>
                          <a:tab algn="l" pos="3755880"/>
                          <a:tab algn="l" pos="4024440"/>
                          <a:tab algn="l" pos="4292640"/>
                          <a:tab algn="l" pos="4560840"/>
                          <a:tab algn="l" pos="4829040"/>
                          <a:tab algn="l" pos="5097600"/>
                          <a:tab algn="l" pos="53658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R1:GGATTCACTTTTAGTGACGCCT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64" name="Rectangle 277"/>
                  <p:cNvGrpSpPr/>
                  <p:nvPr/>
                </p:nvGrpSpPr>
                <p:grpSpPr>
                  <a:xfrm>
                    <a:off x="10144800" y="1663200"/>
                    <a:ext cx="10069920" cy="420480"/>
                    <a:chOff x="10144800" y="1663200"/>
                    <a:chExt cx="10069920" cy="420480"/>
                  </a:xfrm>
                </p:grpSpPr>
                <p:pic>
                  <p:nvPicPr>
                    <p:cNvPr id="65" name="Rectangle 277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0144800" y="1663200"/>
                      <a:ext cx="10069920" cy="4204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66" name=""/>
                    <p:cNvSpPr/>
                    <p:nvPr/>
                  </p:nvSpPr>
                  <p:spPr>
                    <a:xfrm>
                      <a:off x="10172160" y="1691640"/>
                      <a:ext cx="10012320" cy="3650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268200"/>
                          <a:tab algn="l" pos="536400"/>
                          <a:tab algn="l" pos="804960"/>
                          <a:tab algn="l" pos="1073160"/>
                          <a:tab algn="l" pos="1341360"/>
                          <a:tab algn="l" pos="1609560"/>
                          <a:tab algn="l" pos="1878120"/>
                          <a:tab algn="l" pos="2146320"/>
                          <a:tab algn="l" pos="2414520"/>
                          <a:tab algn="l" pos="2682720"/>
                          <a:tab algn="l" pos="2951280"/>
                          <a:tab algn="l" pos="3219480"/>
                          <a:tab algn="l" pos="3487680"/>
                          <a:tab algn="l" pos="3755880"/>
                          <a:tab algn="l" pos="4024440"/>
                          <a:tab algn="l" pos="4292640"/>
                          <a:tab algn="l" pos="4560840"/>
                          <a:tab algn="l" pos="4829040"/>
                          <a:tab algn="l" pos="5097600"/>
                          <a:tab algn="l" pos="53658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2:ATGGACTGGGTCCGCCAGTCTCCAGAGAAGGGGCTTGAGTGGGTTGCTG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67" name="Rectangle 278"/>
                  <p:cNvGrpSpPr/>
                  <p:nvPr/>
                </p:nvGrpSpPr>
                <p:grpSpPr>
                  <a:xfrm>
                    <a:off x="10144800" y="2037600"/>
                    <a:ext cx="10063800" cy="224640"/>
                    <a:chOff x="10144800" y="2037600"/>
                    <a:chExt cx="10063800" cy="224640"/>
                  </a:xfrm>
                </p:grpSpPr>
                <p:pic>
                  <p:nvPicPr>
                    <p:cNvPr id="68" name="Rectangle 278" descr=""/>
                    <p:cNvPicPr/>
                    <p:nvPr/>
                  </p:nvPicPr>
                  <p:blipFill>
                    <a:blip r:embed="rId5"/>
                    <a:stretch/>
                  </p:blipFill>
                  <p:spPr>
                    <a:xfrm>
                      <a:off x="10144800" y="2037600"/>
                      <a:ext cx="10063800" cy="224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69" name=""/>
                    <p:cNvSpPr/>
                    <p:nvPr/>
                  </p:nvSpPr>
                  <p:spPr>
                    <a:xfrm>
                      <a:off x="10173960" y="2063880"/>
                      <a:ext cx="10006200" cy="16956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268200"/>
                          <a:tab algn="l" pos="536400"/>
                          <a:tab algn="l" pos="804960"/>
                          <a:tab algn="l" pos="1073160"/>
                          <a:tab algn="l" pos="1341360"/>
                          <a:tab algn="l" pos="1609560"/>
                          <a:tab algn="l" pos="1878120"/>
                          <a:tab algn="l" pos="2146320"/>
                          <a:tab algn="l" pos="2414520"/>
                          <a:tab algn="l" pos="2682720"/>
                          <a:tab algn="l" pos="2951280"/>
                          <a:tab algn="l" pos="3219480"/>
                          <a:tab algn="l" pos="3487680"/>
                          <a:tab algn="l" pos="3755880"/>
                          <a:tab algn="l" pos="4024440"/>
                          <a:tab algn="l" pos="4292640"/>
                          <a:tab algn="l" pos="4560840"/>
                          <a:tab algn="l" pos="4829040"/>
                          <a:tab algn="l" pos="5097600"/>
                          <a:tab algn="l" pos="53658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R2: ATTAGAAACAAAGCTAATAATCATGCAA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70" name="Rectangle 279"/>
                  <p:cNvGrpSpPr/>
                  <p:nvPr/>
                </p:nvGrpSpPr>
                <p:grpSpPr>
                  <a:xfrm>
                    <a:off x="10139040" y="2221920"/>
                    <a:ext cx="10057680" cy="385920"/>
                    <a:chOff x="10139040" y="2221920"/>
                    <a:chExt cx="10057680" cy="385920"/>
                  </a:xfrm>
                </p:grpSpPr>
                <p:pic>
                  <p:nvPicPr>
                    <p:cNvPr id="71" name="Rectangle 279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10139040" y="2221920"/>
                      <a:ext cx="10057680" cy="385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72" name=""/>
                    <p:cNvSpPr/>
                    <p:nvPr/>
                  </p:nvSpPr>
                  <p:spPr>
                    <a:xfrm>
                      <a:off x="10163880" y="2250360"/>
                      <a:ext cx="10006200" cy="3312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268200"/>
                          <a:tab algn="l" pos="536400"/>
                          <a:tab algn="l" pos="804960"/>
                          <a:tab algn="l" pos="1073160"/>
                          <a:tab algn="l" pos="1341360"/>
                          <a:tab algn="l" pos="1609560"/>
                          <a:tab algn="l" pos="1878120"/>
                          <a:tab algn="l" pos="2146320"/>
                          <a:tab algn="l" pos="2414520"/>
                          <a:tab algn="l" pos="2682720"/>
                          <a:tab algn="l" pos="2951280"/>
                          <a:tab algn="l" pos="3219480"/>
                          <a:tab algn="l" pos="3487680"/>
                          <a:tab algn="l" pos="3755880"/>
                          <a:tab algn="l" pos="4024440"/>
                          <a:tab algn="l" pos="4292640"/>
                          <a:tab algn="l" pos="4560840"/>
                          <a:tab algn="l" pos="4829040"/>
                          <a:tab algn="l" pos="5097600"/>
                          <a:tab algn="l" pos="53658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R3:TACTATGCTGAGTCTGTGAAAGGGAGGTTCACCATCTCAAGAGATGATTCCAAAAGTAGTGTCTACCTGCAAATGAACAACTTAAGAGCTGAAGACACTGGCATTTATT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73" name="Rectangle 280"/>
                  <p:cNvGrpSpPr/>
                  <p:nvPr/>
                </p:nvGrpSpPr>
                <p:grpSpPr>
                  <a:xfrm>
                    <a:off x="10144800" y="2579040"/>
                    <a:ext cx="10069920" cy="259200"/>
                    <a:chOff x="10144800" y="2579040"/>
                    <a:chExt cx="10069920" cy="259200"/>
                  </a:xfrm>
                </p:grpSpPr>
                <p:pic>
                  <p:nvPicPr>
                    <p:cNvPr id="74" name="Rectangle 280" descr=""/>
                    <p:cNvPicPr/>
                    <p:nvPr/>
                  </p:nvPicPr>
                  <p:blipFill>
                    <a:blip r:embed="rId7"/>
                    <a:stretch/>
                  </p:blipFill>
                  <p:spPr>
                    <a:xfrm>
                      <a:off x="10144800" y="2579040"/>
                      <a:ext cx="10069920" cy="259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75" name=""/>
                    <p:cNvSpPr/>
                    <p:nvPr/>
                  </p:nvSpPr>
                  <p:spPr>
                    <a:xfrm>
                      <a:off x="10172160" y="2602440"/>
                      <a:ext cx="10012320" cy="2084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268200"/>
                          <a:tab algn="l" pos="536400"/>
                          <a:tab algn="l" pos="804960"/>
                          <a:tab algn="l" pos="1073160"/>
                          <a:tab algn="l" pos="1341360"/>
                          <a:tab algn="l" pos="1609560"/>
                          <a:tab algn="l" pos="1878120"/>
                          <a:tab algn="l" pos="2146320"/>
                          <a:tab algn="l" pos="2414520"/>
                          <a:tab algn="l" pos="2682720"/>
                          <a:tab algn="l" pos="2951280"/>
                          <a:tab algn="l" pos="3219480"/>
                          <a:tab algn="l" pos="3487680"/>
                          <a:tab algn="l" pos="3755880"/>
                          <a:tab algn="l" pos="4024440"/>
                          <a:tab algn="l" pos="4292640"/>
                          <a:tab algn="l" pos="4560840"/>
                          <a:tab algn="l" pos="4829040"/>
                          <a:tab algn="l" pos="5097600"/>
                          <a:tab algn="l" pos="53658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268200"/>
                          <a:tab algn="l" pos="536400"/>
                          <a:tab algn="l" pos="804960"/>
                          <a:tab algn="l" pos="1073160"/>
                          <a:tab algn="l" pos="1341360"/>
                          <a:tab algn="l" pos="1609560"/>
                          <a:tab algn="l" pos="1878120"/>
                          <a:tab algn="l" pos="2146320"/>
                          <a:tab algn="l" pos="2414520"/>
                          <a:tab algn="l" pos="2682720"/>
                          <a:tab algn="l" pos="2951280"/>
                          <a:tab algn="l" pos="3219480"/>
                          <a:tab algn="l" pos="3487680"/>
                          <a:tab algn="l" pos="3755880"/>
                          <a:tab algn="l" pos="4024440"/>
                          <a:tab algn="l" pos="4292640"/>
                          <a:tab algn="l" pos="4560840"/>
                          <a:tab algn="l" pos="4829040"/>
                          <a:tab algn="l" pos="5097600"/>
                          <a:tab algn="l" pos="53658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R3:TGTACCAGGCTCTATTACTACGGTAGTACCTACTACTTTGACTAC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268200"/>
                          <a:tab algn="l" pos="536400"/>
                          <a:tab algn="l" pos="804960"/>
                          <a:tab algn="l" pos="1073160"/>
                          <a:tab algn="l" pos="1341360"/>
                          <a:tab algn="l" pos="1609560"/>
                          <a:tab algn="l" pos="1878120"/>
                          <a:tab algn="l" pos="2146320"/>
                          <a:tab algn="l" pos="2414520"/>
                          <a:tab algn="l" pos="2682720"/>
                          <a:tab algn="l" pos="2951280"/>
                          <a:tab algn="l" pos="3219480"/>
                          <a:tab algn="l" pos="3487680"/>
                          <a:tab algn="l" pos="3755880"/>
                          <a:tab algn="l" pos="4024440"/>
                          <a:tab algn="l" pos="4292640"/>
                          <a:tab algn="l" pos="4560840"/>
                          <a:tab algn="l" pos="4829040"/>
                          <a:tab algn="l" pos="5097600"/>
                          <a:tab algn="l" pos="53658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grpSp>
              <p:nvGrpSpPr>
                <p:cNvPr id="76" name="Rectangle 368"/>
                <p:cNvGrpSpPr/>
                <p:nvPr/>
              </p:nvGrpSpPr>
              <p:grpSpPr>
                <a:xfrm>
                  <a:off x="10119960" y="2813040"/>
                  <a:ext cx="10119240" cy="267480"/>
                  <a:chOff x="10119960" y="2813040"/>
                  <a:chExt cx="10119240" cy="267480"/>
                </a:xfrm>
              </p:grpSpPr>
              <p:pic>
                <p:nvPicPr>
                  <p:cNvPr id="77" name="Rectangle 368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0119960" y="2813040"/>
                    <a:ext cx="10119240" cy="267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78" name=""/>
                  <p:cNvSpPr/>
                  <p:nvPr/>
                </p:nvSpPr>
                <p:spPr>
                  <a:xfrm>
                    <a:off x="10149120" y="2837880"/>
                    <a:ext cx="10061280" cy="214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just">
                      <a:lnSpc>
                        <a:spcPct val="100000"/>
                      </a:lnSpc>
                      <a:tabLst>
                        <a:tab algn="l" pos="0"/>
                        <a:tab algn="l" pos="268200"/>
                        <a:tab algn="l" pos="536400"/>
                        <a:tab algn="l" pos="804960"/>
                        <a:tab algn="l" pos="1073160"/>
                        <a:tab algn="l" pos="1341360"/>
                        <a:tab algn="l" pos="1609560"/>
                        <a:tab algn="l" pos="1878120"/>
                        <a:tab algn="l" pos="2146320"/>
                        <a:tab algn="l" pos="2414520"/>
                        <a:tab algn="l" pos="2682720"/>
                        <a:tab algn="l" pos="2951280"/>
                        <a:tab algn="l" pos="3219480"/>
                        <a:tab algn="l" pos="3487680"/>
                        <a:tab algn="l" pos="3755880"/>
                        <a:tab algn="l" pos="4024440"/>
                        <a:tab algn="l" pos="4292640"/>
                        <a:tab algn="l" pos="4560840"/>
                        <a:tab algn="l" pos="4829040"/>
                        <a:tab algn="l" pos="5097600"/>
                        <a:tab algn="l" pos="5365800"/>
                      </a:tabLst>
                    </a:pPr>
                    <a:r>
                      <a:rPr b="1" lang="en-GB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FR4:GGCCAAGGCACCACTCTCACAGTCTCCTCAG 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79" name="Rectangle 395"/>
                <p:cNvGrpSpPr/>
                <p:nvPr/>
              </p:nvGrpSpPr>
              <p:grpSpPr>
                <a:xfrm>
                  <a:off x="10114200" y="785880"/>
                  <a:ext cx="10113120" cy="273240"/>
                  <a:chOff x="10114200" y="785880"/>
                  <a:chExt cx="10113120" cy="273240"/>
                </a:xfrm>
              </p:grpSpPr>
              <p:pic>
                <p:nvPicPr>
                  <p:cNvPr id="80" name="Rectangle 395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10114200" y="785880"/>
                    <a:ext cx="10113120" cy="273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81" name=""/>
                  <p:cNvSpPr/>
                  <p:nvPr/>
                </p:nvSpPr>
                <p:spPr>
                  <a:xfrm>
                    <a:off x="10139400" y="815040"/>
                    <a:ext cx="10060200" cy="2145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268200"/>
                        <a:tab algn="l" pos="536400"/>
                        <a:tab algn="l" pos="804960"/>
                        <a:tab algn="l" pos="1073160"/>
                        <a:tab algn="l" pos="1341360"/>
                        <a:tab algn="l" pos="1609560"/>
                        <a:tab algn="l" pos="1878120"/>
                        <a:tab algn="l" pos="2146320"/>
                        <a:tab algn="l" pos="2414520"/>
                        <a:tab algn="l" pos="2682720"/>
                        <a:tab algn="l" pos="2951280"/>
                        <a:tab algn="l" pos="3219480"/>
                        <a:tab algn="l" pos="3487680"/>
                        <a:tab algn="l" pos="3755880"/>
                        <a:tab algn="l" pos="4024440"/>
                        <a:tab algn="l" pos="4292640"/>
                        <a:tab algn="l" pos="4560840"/>
                        <a:tab algn="l" pos="4829040"/>
                        <a:tab algn="l" pos="5097600"/>
                        <a:tab algn="l" pos="5365800"/>
                      </a:tabLst>
                    </a:pPr>
                    <a:r>
                      <a:rPr b="1" lang="en-GB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DNA sequence of CDRs and FRs of Heavy chain 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82" name="Straight Connector 411"/>
              <p:cNvSpPr/>
              <p:nvPr/>
            </p:nvSpPr>
            <p:spPr>
              <a:xfrm>
                <a:off x="394920" y="3132000"/>
                <a:ext cx="7196400" cy="904680"/>
              </a:xfrm>
              <a:prstGeom prst="line">
                <a:avLst/>
              </a:prstGeom>
              <a:ln w="12600">
                <a:solidFill>
                  <a:srgbClr val="ed7d31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Straight Connector 413"/>
              <p:cNvSpPr/>
              <p:nvPr/>
            </p:nvSpPr>
            <p:spPr>
              <a:xfrm flipV="1">
                <a:off x="12813120" y="3103560"/>
                <a:ext cx="7421760" cy="1388880"/>
              </a:xfrm>
              <a:prstGeom prst="line">
                <a:avLst/>
              </a:prstGeom>
              <a:ln w="12600">
                <a:solidFill>
                  <a:srgbClr val="ed7d31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" name="TextBox 242"/>
            <p:cNvSpPr/>
            <p:nvPr/>
          </p:nvSpPr>
          <p:spPr>
            <a:xfrm>
              <a:off x="276120" y="54000"/>
              <a:ext cx="1652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uppl Figure 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5-11T14:14:34Z</dcterms:created>
  <dc:creator>Nefeli Lagopati</dc:creator>
  <dc:description/>
  <dc:language>en-US</dc:language>
  <cp:lastModifiedBy>Λογαριασμός Microsoft</cp:lastModifiedBy>
  <dcterms:modified xsi:type="dcterms:W3CDTF">2021-05-12T10:02:16Z</dcterms:modified>
  <cp:revision>6</cp:revision>
  <dc:subject/>
  <dc:title>Παρουσίαση του PowerPoint</dc:title>
</cp:coreProperties>
</file>